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6"/>
  </p:notesMasterIdLst>
  <p:sldIdLst>
    <p:sldId id="332" r:id="rId5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B1991432-16D4-A338-8C74-AA5AE8E7A6BA}" name="BeKa Leuschen-Kohl" initials="BLK" userId="BeKa Leuschen-Kohl" providerId="None"/>
  <p188:author id="{152ED23C-9289-3640-DC9D-A0185063BC84}" name="Iyer-Pascuzzi, Anjali" initials="IA" userId="S::aiyerpas@purdue.edu::dcf03dc3-b88b-4fb8-8f79-4d9cab98b2b3" providerId="AD"/>
  <p188:author id="{22EA6AEE-A713-B989-205E-2187CD1F1D1A}" name="Rebecca Lynn Leuschen-kohl" initials="RL" userId="S::rleusche@purdue.edu::00225fb4-0928-44a2-820d-794618e88de9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DBDBD"/>
    <a:srgbClr val="949F95"/>
    <a:srgbClr val="DEDEDE"/>
    <a:srgbClr val="ADB9CA"/>
    <a:srgbClr val="FFFFFF"/>
    <a:srgbClr val="4F4390"/>
    <a:srgbClr val="FFBDDE"/>
    <a:srgbClr val="B3B3B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2" d="100"/>
          <a:sy n="72" d="100"/>
        </p:scale>
        <p:origin x="2979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ebecca Leuschen-Kohl" userId="ef62846a7a2008e6" providerId="LiveId" clId="{AB299281-1904-449B-AFB8-C0A699A80455}"/>
    <pc:docChg chg="delSld modSld">
      <pc:chgData name="Rebecca Leuschen-Kohl" userId="ef62846a7a2008e6" providerId="LiveId" clId="{AB299281-1904-449B-AFB8-C0A699A80455}" dt="2024-11-05T00:49:54.665" v="9" actId="47"/>
      <pc:docMkLst>
        <pc:docMk/>
      </pc:docMkLst>
      <pc:sldChg chg="modSp mod">
        <pc:chgData name="Rebecca Leuschen-Kohl" userId="ef62846a7a2008e6" providerId="LiveId" clId="{AB299281-1904-449B-AFB8-C0A699A80455}" dt="2024-11-05T00:49:45.853" v="8" actId="20577"/>
        <pc:sldMkLst>
          <pc:docMk/>
          <pc:sldMk cId="830658197" sldId="332"/>
        </pc:sldMkLst>
        <pc:spChg chg="mod">
          <ac:chgData name="Rebecca Leuschen-Kohl" userId="ef62846a7a2008e6" providerId="LiveId" clId="{AB299281-1904-449B-AFB8-C0A699A80455}" dt="2024-11-05T00:49:45.853" v="8" actId="20577"/>
          <ac:spMkLst>
            <pc:docMk/>
            <pc:sldMk cId="830658197" sldId="332"/>
            <ac:spMk id="2" creationId="{9692352F-DB4F-E6B7-8A06-4A59580FE3FE}"/>
          </ac:spMkLst>
        </pc:spChg>
      </pc:sldChg>
      <pc:sldChg chg="del">
        <pc:chgData name="Rebecca Leuschen-Kohl" userId="ef62846a7a2008e6" providerId="LiveId" clId="{AB299281-1904-449B-AFB8-C0A699A80455}" dt="2024-11-05T00:49:33.677" v="0" actId="47"/>
        <pc:sldMkLst>
          <pc:docMk/>
          <pc:sldMk cId="3398032437" sldId="336"/>
        </pc:sldMkLst>
      </pc:sldChg>
      <pc:sldChg chg="del">
        <pc:chgData name="Rebecca Leuschen-Kohl" userId="ef62846a7a2008e6" providerId="LiveId" clId="{AB299281-1904-449B-AFB8-C0A699A80455}" dt="2024-11-05T00:49:33.677" v="0" actId="47"/>
        <pc:sldMkLst>
          <pc:docMk/>
          <pc:sldMk cId="3793326182" sldId="338"/>
        </pc:sldMkLst>
      </pc:sldChg>
      <pc:sldChg chg="del">
        <pc:chgData name="Rebecca Leuschen-Kohl" userId="ef62846a7a2008e6" providerId="LiveId" clId="{AB299281-1904-449B-AFB8-C0A699A80455}" dt="2024-11-05T00:49:54.665" v="9" actId="47"/>
        <pc:sldMkLst>
          <pc:docMk/>
          <pc:sldMk cId="1961722243" sldId="339"/>
        </pc:sldMkLst>
      </pc:sldChg>
      <pc:sldChg chg="del">
        <pc:chgData name="Rebecca Leuschen-Kohl" userId="ef62846a7a2008e6" providerId="LiveId" clId="{AB299281-1904-449B-AFB8-C0A699A80455}" dt="2024-11-05T00:49:33.677" v="0" actId="47"/>
        <pc:sldMkLst>
          <pc:docMk/>
          <pc:sldMk cId="2349073536" sldId="347"/>
        </pc:sldMkLst>
      </pc:sldChg>
      <pc:sldChg chg="del">
        <pc:chgData name="Rebecca Leuschen-Kohl" userId="ef62846a7a2008e6" providerId="LiveId" clId="{AB299281-1904-449B-AFB8-C0A699A80455}" dt="2024-11-05T00:49:33.677" v="0" actId="47"/>
        <pc:sldMkLst>
          <pc:docMk/>
          <pc:sldMk cId="830734933" sldId="348"/>
        </pc:sldMkLst>
      </pc:sldChg>
      <pc:sldChg chg="del">
        <pc:chgData name="Rebecca Leuschen-Kohl" userId="ef62846a7a2008e6" providerId="LiveId" clId="{AB299281-1904-449B-AFB8-C0A699A80455}" dt="2024-11-05T00:49:33.677" v="0" actId="47"/>
        <pc:sldMkLst>
          <pc:docMk/>
          <pc:sldMk cId="397969387" sldId="349"/>
        </pc:sldMkLst>
      </pc:sldChg>
      <pc:sldChg chg="del">
        <pc:chgData name="Rebecca Leuschen-Kohl" userId="ef62846a7a2008e6" providerId="LiveId" clId="{AB299281-1904-449B-AFB8-C0A699A80455}" dt="2024-11-05T00:49:33.677" v="0" actId="47"/>
        <pc:sldMkLst>
          <pc:docMk/>
          <pc:sldMk cId="1704172087" sldId="351"/>
        </pc:sldMkLst>
      </pc:sldChg>
      <pc:sldChg chg="del">
        <pc:chgData name="Rebecca Leuschen-Kohl" userId="ef62846a7a2008e6" providerId="LiveId" clId="{AB299281-1904-449B-AFB8-C0A699A80455}" dt="2024-11-05T00:49:33.677" v="0" actId="47"/>
        <pc:sldMkLst>
          <pc:docMk/>
          <pc:sldMk cId="3486478879" sldId="353"/>
        </pc:sldMkLst>
      </pc:sldChg>
      <pc:sldChg chg="del">
        <pc:chgData name="Rebecca Leuschen-Kohl" userId="ef62846a7a2008e6" providerId="LiveId" clId="{AB299281-1904-449B-AFB8-C0A699A80455}" dt="2024-11-05T00:49:33.677" v="0" actId="47"/>
        <pc:sldMkLst>
          <pc:docMk/>
          <pc:sldMk cId="2478473178" sldId="354"/>
        </pc:sldMkLst>
      </pc:sldChg>
      <pc:sldChg chg="del">
        <pc:chgData name="Rebecca Leuschen-Kohl" userId="ef62846a7a2008e6" providerId="LiveId" clId="{AB299281-1904-449B-AFB8-C0A699A80455}" dt="2024-11-05T00:49:35.237" v="1" actId="47"/>
        <pc:sldMkLst>
          <pc:docMk/>
          <pc:sldMk cId="2416863298" sldId="355"/>
        </pc:sldMkLst>
      </pc:sldChg>
      <pc:sldChg chg="del">
        <pc:chgData name="Rebecca Leuschen-Kohl" userId="ef62846a7a2008e6" providerId="LiveId" clId="{AB299281-1904-449B-AFB8-C0A699A80455}" dt="2024-11-05T00:49:33.677" v="0" actId="47"/>
        <pc:sldMkLst>
          <pc:docMk/>
          <pc:sldMk cId="568157699" sldId="356"/>
        </pc:sldMkLst>
      </pc:sldChg>
      <pc:sldChg chg="del">
        <pc:chgData name="Rebecca Leuschen-Kohl" userId="ef62846a7a2008e6" providerId="LiveId" clId="{AB299281-1904-449B-AFB8-C0A699A80455}" dt="2024-11-05T00:49:33.677" v="0" actId="47"/>
        <pc:sldMkLst>
          <pc:docMk/>
          <pc:sldMk cId="1185421222" sldId="359"/>
        </pc:sldMkLst>
      </pc:sldChg>
      <pc:sldChg chg="del">
        <pc:chgData name="Rebecca Leuschen-Kohl" userId="ef62846a7a2008e6" providerId="LiveId" clId="{AB299281-1904-449B-AFB8-C0A699A80455}" dt="2024-11-05T00:49:33.677" v="0" actId="47"/>
        <pc:sldMkLst>
          <pc:docMk/>
          <pc:sldMk cId="83140915" sldId="361"/>
        </pc:sldMkLst>
      </pc:sldChg>
      <pc:sldChg chg="del">
        <pc:chgData name="Rebecca Leuschen-Kohl" userId="ef62846a7a2008e6" providerId="LiveId" clId="{AB299281-1904-449B-AFB8-C0A699A80455}" dt="2024-11-05T00:49:33.677" v="0" actId="47"/>
        <pc:sldMkLst>
          <pc:docMk/>
          <pc:sldMk cId="58006295" sldId="363"/>
        </pc:sldMkLst>
      </pc:sldChg>
      <pc:sldChg chg="del">
        <pc:chgData name="Rebecca Leuschen-Kohl" userId="ef62846a7a2008e6" providerId="LiveId" clId="{AB299281-1904-449B-AFB8-C0A699A80455}" dt="2024-11-05T00:49:33.677" v="0" actId="47"/>
        <pc:sldMkLst>
          <pc:docMk/>
          <pc:sldMk cId="4206593612" sldId="364"/>
        </pc:sldMkLst>
      </pc:sldChg>
      <pc:sldChg chg="del">
        <pc:chgData name="Rebecca Leuschen-Kohl" userId="ef62846a7a2008e6" providerId="LiveId" clId="{AB299281-1904-449B-AFB8-C0A699A80455}" dt="2024-11-05T00:49:36.030" v="2" actId="47"/>
        <pc:sldMkLst>
          <pc:docMk/>
          <pc:sldMk cId="2301688996" sldId="365"/>
        </pc:sldMkLst>
      </pc:sldChg>
      <pc:sldChg chg="del">
        <pc:chgData name="Rebecca Leuschen-Kohl" userId="ef62846a7a2008e6" providerId="LiveId" clId="{AB299281-1904-449B-AFB8-C0A699A80455}" dt="2024-11-05T00:49:54.665" v="9" actId="47"/>
        <pc:sldMkLst>
          <pc:docMk/>
          <pc:sldMk cId="471017098" sldId="366"/>
        </pc:sldMkLst>
      </pc:sldChg>
      <pc:sldChg chg="del">
        <pc:chgData name="Rebecca Leuschen-Kohl" userId="ef62846a7a2008e6" providerId="LiveId" clId="{AB299281-1904-449B-AFB8-C0A699A80455}" dt="2024-11-05T00:49:54.665" v="9" actId="47"/>
        <pc:sldMkLst>
          <pc:docMk/>
          <pc:sldMk cId="1752517358" sldId="367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5C9A0A-66B1-4FAF-A1C5-2E9142573E35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C2AFF7-3C64-424C-82FD-976B3E97E4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7658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CC2AFF7-3C64-424C-82FD-976B3E97E48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03892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3690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70486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90667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7405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88638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9952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20658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90355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84083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6613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6204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18833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 descr="A screenshot of a graph&#10;&#10;Description automatically generated">
            <a:extLst>
              <a:ext uri="{FF2B5EF4-FFF2-40B4-BE49-F238E27FC236}">
                <a16:creationId xmlns:a16="http://schemas.microsoft.com/office/drawing/2014/main" id="{C073D81E-EEEB-6FE2-9789-1B5555D0D72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6169" y="2561081"/>
            <a:ext cx="5690514" cy="3556571"/>
          </a:xfrm>
          <a:prstGeom prst="rect">
            <a:avLst/>
          </a:prstGeom>
        </p:spPr>
      </p:pic>
      <p:sp>
        <p:nvSpPr>
          <p:cNvPr id="41" name="Left Bracket 40">
            <a:extLst>
              <a:ext uri="{FF2B5EF4-FFF2-40B4-BE49-F238E27FC236}">
                <a16:creationId xmlns:a16="http://schemas.microsoft.com/office/drawing/2014/main" id="{FD6450EB-7D4C-4EF2-5E78-BD67887D7226}"/>
              </a:ext>
            </a:extLst>
          </p:cNvPr>
          <p:cNvSpPr/>
          <p:nvPr/>
        </p:nvSpPr>
        <p:spPr>
          <a:xfrm rot="5400000">
            <a:off x="1941597" y="3570514"/>
            <a:ext cx="45719" cy="303035"/>
          </a:xfrm>
          <a:prstGeom prst="leftBracket">
            <a:avLst>
              <a:gd name="adj" fmla="val 0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86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9E4BD02-0CCC-EB93-B149-795170F21284}"/>
              </a:ext>
            </a:extLst>
          </p:cNvPr>
          <p:cNvSpPr txBox="1"/>
          <p:nvPr/>
        </p:nvSpPr>
        <p:spPr>
          <a:xfrm>
            <a:off x="1858045" y="3528534"/>
            <a:ext cx="2128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Helvetica" panose="020B0604020202020204" pitchFamily="34" charset="0"/>
                <a:cs typeface="Helvetica" panose="020B0604020202020204" pitchFamily="34" charset="0"/>
              </a:rPr>
              <a:t>*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692352F-DB4F-E6B7-8A06-4A59580FE3FE}"/>
              </a:ext>
            </a:extLst>
          </p:cNvPr>
          <p:cNvSpPr txBox="1"/>
          <p:nvPr/>
        </p:nvSpPr>
        <p:spPr>
          <a:xfrm>
            <a:off x="926169" y="462008"/>
            <a:ext cx="5511986" cy="1015663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defTabSz="274012"/>
            <a:r>
              <a:rPr lang="en-US" sz="1000" b="1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Fig. S6. </a:t>
            </a:r>
            <a:r>
              <a:rPr lang="en-US" sz="10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Temporary root growth inhibition is observed in 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Arabidopsis </a:t>
            </a:r>
            <a:r>
              <a:rPr lang="en-US" sz="10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seedlings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 </a:t>
            </a:r>
            <a:r>
              <a:rPr lang="en-US" sz="10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for flg22</a:t>
            </a:r>
            <a:r>
              <a:rPr lang="en-US" sz="10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Pto</a:t>
            </a:r>
            <a:r>
              <a:rPr lang="en-US" sz="10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 treatment at 24 hpi, </a:t>
            </a:r>
            <a:r>
              <a:rPr lang="en-US" sz="1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but not earlier.​ Change in root growth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cm/24 hour) for Arabidopsis roots of from 0-24 hours, 24-48 hours, and 48-72 hours post inoculation. Arabidopsis (</a:t>
            </a:r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Col-0 seedlings treated with 1 µM flg22</a:t>
            </a:r>
            <a:r>
              <a:rPr lang="en-US" sz="10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to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r mock (water), (</a:t>
            </a:r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Col-0, </a:t>
            </a:r>
            <a:r>
              <a:rPr lang="en-US" sz="1000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bohD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nd </a:t>
            </a:r>
            <a:r>
              <a:rPr lang="en-US" sz="1000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bohD</a:t>
            </a:r>
            <a:r>
              <a:rPr lang="en-US" sz="10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</a:t>
            </a:r>
            <a:r>
              <a:rPr lang="en-US" sz="1000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bohF</a:t>
            </a:r>
            <a:r>
              <a:rPr lang="en-US" sz="10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eedlings treated with 1 µM flg22</a:t>
            </a:r>
            <a:r>
              <a:rPr lang="en-US" sz="10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to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r mock (water). </a:t>
            </a:r>
            <a:r>
              <a:rPr lang="en-US" sz="1000" dirty="0">
                <a:solidFill>
                  <a:srgbClr val="111111"/>
                </a:solidFill>
                <a:latin typeface="Times New Roman" panose="02020603050405020304" pitchFamily="18" charset="0"/>
                <a:ea typeface="Roboto"/>
                <a:cs typeface="Times New Roman" panose="02020603050405020304" pitchFamily="18" charset="0"/>
              </a:rPr>
              <a:t>Values represent the mean ±SD from at least 18 roots per treatment 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Wilcoxon,</a:t>
            </a:r>
            <a:r>
              <a:rPr lang="en-US" sz="10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*p&lt;0.05, **p&lt;0.01, ***p&lt;0.001, ****p&lt;0.0001). </a:t>
            </a:r>
            <a:endParaRPr lang="en-US" sz="10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8" name="Left Bracket 17">
            <a:extLst>
              <a:ext uri="{FF2B5EF4-FFF2-40B4-BE49-F238E27FC236}">
                <a16:creationId xmlns:a16="http://schemas.microsoft.com/office/drawing/2014/main" id="{A8A7EA7C-5281-F02E-7C72-108AD404791B}"/>
              </a:ext>
            </a:extLst>
          </p:cNvPr>
          <p:cNvSpPr/>
          <p:nvPr/>
        </p:nvSpPr>
        <p:spPr>
          <a:xfrm rot="5400000">
            <a:off x="4575476" y="3680413"/>
            <a:ext cx="45719" cy="157905"/>
          </a:xfrm>
          <a:prstGeom prst="leftBracket">
            <a:avLst>
              <a:gd name="adj" fmla="val 0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86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28EA5CB-896D-8BA1-3F4A-AA8CD516E9EB}"/>
              </a:ext>
            </a:extLst>
          </p:cNvPr>
          <p:cNvSpPr txBox="1"/>
          <p:nvPr/>
        </p:nvSpPr>
        <p:spPr>
          <a:xfrm>
            <a:off x="4562750" y="3583756"/>
            <a:ext cx="682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Helvetica" panose="020B0604020202020204" pitchFamily="34" charset="0"/>
                <a:cs typeface="Helvetica" panose="020B0604020202020204" pitchFamily="34" charset="0"/>
              </a:rPr>
              <a:t>*</a:t>
            </a:r>
          </a:p>
        </p:txBody>
      </p:sp>
      <p:sp>
        <p:nvSpPr>
          <p:cNvPr id="22" name="Left Bracket 21">
            <a:extLst>
              <a:ext uri="{FF2B5EF4-FFF2-40B4-BE49-F238E27FC236}">
                <a16:creationId xmlns:a16="http://schemas.microsoft.com/office/drawing/2014/main" id="{4E232BC3-EEDA-A543-25F1-96BB07449BC1}"/>
              </a:ext>
            </a:extLst>
          </p:cNvPr>
          <p:cNvSpPr/>
          <p:nvPr/>
        </p:nvSpPr>
        <p:spPr>
          <a:xfrm rot="5400000">
            <a:off x="4798934" y="3835841"/>
            <a:ext cx="45719" cy="157905"/>
          </a:xfrm>
          <a:prstGeom prst="leftBracket">
            <a:avLst>
              <a:gd name="adj" fmla="val 0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86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F78DDC6-51CD-A8BB-0044-D7F9AA5EEA77}"/>
              </a:ext>
            </a:extLst>
          </p:cNvPr>
          <p:cNvSpPr txBox="1"/>
          <p:nvPr/>
        </p:nvSpPr>
        <p:spPr>
          <a:xfrm>
            <a:off x="4792461" y="3736506"/>
            <a:ext cx="682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Helvetica" panose="020B0604020202020204" pitchFamily="34" charset="0"/>
                <a:cs typeface="Helvetica" panose="020B0604020202020204" pitchFamily="34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8306581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974c5d5a-69c4-47c0-8134-bb286fa4472c">
      <Terms xmlns="http://schemas.microsoft.com/office/infopath/2007/PartnerControls"/>
    </lcf76f155ced4ddcb4097134ff3c332f>
    <TaxCatchAll xmlns="746cde4b-492d-48ba-92d7-9676a22a1012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56102D0D35E964BBFE2C79D04696EE4" ma:contentTypeVersion="18" ma:contentTypeDescription="Create a new document." ma:contentTypeScope="" ma:versionID="71fc2afbc31600472ab73e35b249ead8">
  <xsd:schema xmlns:xsd="http://www.w3.org/2001/XMLSchema" xmlns:xs="http://www.w3.org/2001/XMLSchema" xmlns:p="http://schemas.microsoft.com/office/2006/metadata/properties" xmlns:ns2="974c5d5a-69c4-47c0-8134-bb286fa4472c" xmlns:ns3="746cde4b-492d-48ba-92d7-9676a22a1012" targetNamespace="http://schemas.microsoft.com/office/2006/metadata/properties" ma:root="true" ma:fieldsID="23e452dd77b66b46fbeaa7a26eb6c6ab" ns2:_="" ns3:_="">
    <xsd:import namespace="974c5d5a-69c4-47c0-8134-bb286fa4472c"/>
    <xsd:import namespace="746cde4b-492d-48ba-92d7-9676a22a1012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ServiceLocation" minOccurs="0"/>
                <xsd:element ref="ns2:lcf76f155ced4ddcb4097134ff3c332f" minOccurs="0"/>
                <xsd:element ref="ns3:TaxCatchAll" minOccurs="0"/>
                <xsd:element ref="ns2:MediaLengthInSeconds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74c5d5a-69c4-47c0-8134-bb286fa4472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lcf76f155ced4ddcb4097134ff3c332f" ma:index="19" nillable="true" ma:taxonomy="true" ma:internalName="lcf76f155ced4ddcb4097134ff3c332f" ma:taxonomyFieldName="MediaServiceImageTags" ma:displayName="Image Tags" ma:readOnly="false" ma:fieldId="{5cf76f15-5ced-4ddc-b409-7134ff3c332f}" ma:taxonomyMulti="true" ma:sspId="8e9e90a8-b24c-4be7-8760-a88b2cd47eb1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24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46cde4b-492d-48ba-92d7-9676a22a1012" elementFormDefault="qualified">
    <xsd:import namespace="http://schemas.microsoft.com/office/2006/documentManagement/types"/>
    <xsd:import namespace="http://schemas.microsoft.com/office/infopath/2007/PartnerControls"/>
    <xsd:element name="TaxCatchAll" ma:index="20" nillable="true" ma:displayName="Taxonomy Catch All Column" ma:hidden="true" ma:list="{f532aa21-857b-4867-95d0-9dc152152f45}" ma:internalName="TaxCatchAll" ma:showField="CatchAllData" ma:web="746cde4b-492d-48ba-92d7-9676a22a1012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2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5313B5D3-9FE6-4906-868D-5CC357E257CA}">
  <ds:schemaRefs>
    <ds:schemaRef ds:uri="http://schemas.microsoft.com/office/2006/metadata/properties"/>
    <ds:schemaRef ds:uri="974c5d5a-69c4-47c0-8134-bb286fa4472c"/>
    <ds:schemaRef ds:uri="746cde4b-492d-48ba-92d7-9676a22a1012"/>
    <ds:schemaRef ds:uri="http://purl.org/dc/elements/1.1/"/>
    <ds:schemaRef ds:uri="http://schemas.microsoft.com/office/infopath/2007/PartnerControls"/>
    <ds:schemaRef ds:uri="http://www.w3.org/XML/1998/namespace"/>
    <ds:schemaRef ds:uri="http://schemas.microsoft.com/office/2006/documentManagement/types"/>
    <ds:schemaRef ds:uri="http://schemas.openxmlformats.org/package/2006/metadata/core-properties"/>
    <ds:schemaRef ds:uri="http://purl.org/dc/dcmitype/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34E92243-6744-4250-8C81-06A634B89881}">
  <ds:schemaRefs>
    <ds:schemaRef ds:uri="746cde4b-492d-48ba-92d7-9676a22a1012"/>
    <ds:schemaRef ds:uri="974c5d5a-69c4-47c0-8134-bb286fa4472c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3.xml><?xml version="1.0" encoding="utf-8"?>
<ds:datastoreItem xmlns:ds="http://schemas.openxmlformats.org/officeDocument/2006/customXml" ds:itemID="{986C45CB-9F98-4FBA-95D4-669FBCC50C6D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130</Words>
  <Application>Microsoft Office PowerPoint</Application>
  <PresentationFormat>Custom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Times New Roman</vt:lpstr>
      <vt:lpstr>Office 2013 - 2022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!</dc:title>
  <dc:creator>BeKa Leuschen</dc:creator>
  <cp:lastModifiedBy>BeKa Leuschen-Kohl</cp:lastModifiedBy>
  <cp:revision>1</cp:revision>
  <dcterms:created xsi:type="dcterms:W3CDTF">2022-01-14T17:50:55Z</dcterms:created>
  <dcterms:modified xsi:type="dcterms:W3CDTF">2024-11-05T00:49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56102D0D35E964BBFE2C79D04696EE4</vt:lpwstr>
  </property>
  <property fmtid="{D5CDD505-2E9C-101B-9397-08002B2CF9AE}" pid="3" name="MediaServiceImageTags">
    <vt:lpwstr/>
  </property>
  <property fmtid="{D5CDD505-2E9C-101B-9397-08002B2CF9AE}" pid="4" name="MSIP_Label_4044bd30-2ed7-4c9d-9d12-46200872a97b_Enabled">
    <vt:lpwstr>true</vt:lpwstr>
  </property>
  <property fmtid="{D5CDD505-2E9C-101B-9397-08002B2CF9AE}" pid="5" name="MSIP_Label_4044bd30-2ed7-4c9d-9d12-46200872a97b_SetDate">
    <vt:lpwstr>2022-12-15T15:50:22Z</vt:lpwstr>
  </property>
  <property fmtid="{D5CDD505-2E9C-101B-9397-08002B2CF9AE}" pid="6" name="MSIP_Label_4044bd30-2ed7-4c9d-9d12-46200872a97b_Method">
    <vt:lpwstr>Standard</vt:lpwstr>
  </property>
  <property fmtid="{D5CDD505-2E9C-101B-9397-08002B2CF9AE}" pid="7" name="MSIP_Label_4044bd30-2ed7-4c9d-9d12-46200872a97b_Name">
    <vt:lpwstr>defa4170-0d19-0005-0004-bc88714345d2</vt:lpwstr>
  </property>
  <property fmtid="{D5CDD505-2E9C-101B-9397-08002B2CF9AE}" pid="8" name="MSIP_Label_4044bd30-2ed7-4c9d-9d12-46200872a97b_SiteId">
    <vt:lpwstr>4130bd39-7c53-419c-b1e5-8758d6d63f21</vt:lpwstr>
  </property>
  <property fmtid="{D5CDD505-2E9C-101B-9397-08002B2CF9AE}" pid="9" name="MSIP_Label_4044bd30-2ed7-4c9d-9d12-46200872a97b_ActionId">
    <vt:lpwstr>f1376b59-ccc7-4a7c-91ca-02a5a8238883</vt:lpwstr>
  </property>
  <property fmtid="{D5CDD505-2E9C-101B-9397-08002B2CF9AE}" pid="10" name="MSIP_Label_4044bd30-2ed7-4c9d-9d12-46200872a97b_ContentBits">
    <vt:lpwstr>0</vt:lpwstr>
  </property>
</Properties>
</file>